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4C9CD8-2A4C-4672-B0D4-30A0F1A9CF2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3F2B3-4969-4339-AEA7-10A2DB37D9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2DB51-45ED-4055-8869-0C35BCA7AF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6F870-4A1A-4E12-BBC1-5C1BCB318A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F3D1D4-82F2-4CBD-817D-C9CE14B359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7CBCD-3A16-492D-94BD-7F2AE88EA6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43814-4673-490F-AAEE-379249A226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3E4C7-C2C4-4EA3-A284-2387F545B9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35A11-6DD6-447B-A1F6-6037BA46AC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52B87-76A2-4734-B2C9-60E5D3729E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FA639-33D6-4DAE-B777-194C4B6F5D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0C5C5-86E0-40F0-AE9D-8B06D23B34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9602F0-7D8E-453E-8219-8F82F65D1D2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3"/>
          <p:cNvSpPr/>
          <p:nvPr/>
        </p:nvSpPr>
        <p:spPr>
          <a:xfrm>
            <a:off x="5334120" y="8610480"/>
            <a:ext cx="121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62120" y="6477120"/>
            <a:ext cx="5562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S2. Effects of recombinant human BMP-2 (rhBMP-2 and recombinant human WISP-1 (rhWISP-1) on osteogenic differentiation of hBMSC. Real-time PCR showing expression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L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mRNA *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&lt;0.05 vs. untreated sample. ***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&lt;0.001 vs. untreated samp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図 3" descr="Data_1_graph.jpg"/>
          <p:cNvPicPr/>
          <p:nvPr/>
        </p:nvPicPr>
        <p:blipFill>
          <a:blip r:embed="rId1"/>
          <a:stretch/>
        </p:blipFill>
        <p:spPr>
          <a:xfrm>
            <a:off x="2057400" y="2336760"/>
            <a:ext cx="2822400" cy="3835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5T07:46:00Z</dcterms:created>
  <dc:creator>Mitsuaki Ono</dc:creator>
  <dc:description/>
  <dc:language>en-US</dc:language>
  <cp:lastModifiedBy>Marian Young</cp:lastModifiedBy>
  <cp:lastPrinted>2010-02-16T19:51:16Z</cp:lastPrinted>
  <dcterms:modified xsi:type="dcterms:W3CDTF">2010-06-15T19:14:03Z</dcterms:modified>
  <cp:revision>402</cp:revision>
  <dc:subject/>
  <dc:title>PowerPoint Presentation</dc:title>
</cp:coreProperties>
</file>